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7559675" cy="43200638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606">
          <p15:clr>
            <a:srgbClr val="A4A3A4"/>
          </p15:clr>
        </p15:guide>
        <p15:guide id="2" pos="238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46" autoAdjust="0"/>
    <p:restoredTop sz="94660"/>
  </p:normalViewPr>
  <p:slideViewPr>
    <p:cSldViewPr snapToGrid="0">
      <p:cViewPr>
        <p:scale>
          <a:sx n="252" d="100"/>
          <a:sy n="252" d="100"/>
        </p:scale>
        <p:origin x="224" y="-63856"/>
      </p:cViewPr>
      <p:guideLst>
        <p:guide orient="horz" pos="13606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7070108"/>
            <a:ext cx="6425724" cy="15040222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22690338"/>
            <a:ext cx="5669756" cy="10430151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BFB78-0366-4696-BB41-140FFADF005B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FED3D-B504-48D4-A8B8-DFFEB8751E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5555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BFB78-0366-4696-BB41-140FFADF005B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FED3D-B504-48D4-A8B8-DFFEB8751E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1971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2300034"/>
            <a:ext cx="1630055" cy="3661054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2300034"/>
            <a:ext cx="4795669" cy="3661054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BFB78-0366-4696-BB41-140FFADF005B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FED3D-B504-48D4-A8B8-DFFEB8751E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87537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BFB78-0366-4696-BB41-140FFADF005B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FED3D-B504-48D4-A8B8-DFFEB8751E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83570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10770172"/>
            <a:ext cx="6520220" cy="17970262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28910440"/>
            <a:ext cx="6520220" cy="9450136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BFB78-0366-4696-BB41-140FFADF005B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FED3D-B504-48D4-A8B8-DFFEB8751E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1352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11500170"/>
            <a:ext cx="3212862" cy="2741040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11500170"/>
            <a:ext cx="3212862" cy="2741040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BFB78-0366-4696-BB41-140FFADF005B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FED3D-B504-48D4-A8B8-DFFEB8751E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2026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2300044"/>
            <a:ext cx="6520220" cy="835012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10590160"/>
            <a:ext cx="3198096" cy="5190073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15780233"/>
            <a:ext cx="3198096" cy="2321034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10590160"/>
            <a:ext cx="3213847" cy="5190073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15780233"/>
            <a:ext cx="3213847" cy="2321034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BFB78-0366-4696-BB41-140FFADF005B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FED3D-B504-48D4-A8B8-DFFEB8751E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90219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BFB78-0366-4696-BB41-140FFADF005B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FED3D-B504-48D4-A8B8-DFFEB8751E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4304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BFB78-0366-4696-BB41-140FFADF005B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FED3D-B504-48D4-A8B8-DFFEB8751E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33898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2880042"/>
            <a:ext cx="2438192" cy="10080149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6220102"/>
            <a:ext cx="3827085" cy="30700453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12960191"/>
            <a:ext cx="2438192" cy="24010358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BFB78-0366-4696-BB41-140FFADF005B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FED3D-B504-48D4-A8B8-DFFEB8751E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91363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2880042"/>
            <a:ext cx="2438192" cy="10080149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6220102"/>
            <a:ext cx="3827085" cy="30700453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12960191"/>
            <a:ext cx="2438192" cy="24010358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BFB78-0366-4696-BB41-140FFADF005B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FED3D-B504-48D4-A8B8-DFFEB8751E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857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2300044"/>
            <a:ext cx="6520220" cy="8350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11500170"/>
            <a:ext cx="6520220" cy="2741040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40040601"/>
            <a:ext cx="1700927" cy="23000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9BFB78-0366-4696-BB41-140FFADF005B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40040601"/>
            <a:ext cx="2551390" cy="23000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40040601"/>
            <a:ext cx="1700927" cy="23000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DFED3D-B504-48D4-A8B8-DFFEB8751E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15835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kumimoji="1"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0837" y="117441"/>
            <a:ext cx="6858000" cy="42965756"/>
          </a:xfrm>
          <a:prstGeom prst="rect">
            <a:avLst/>
          </a:prstGeom>
        </p:spPr>
      </p:pic>
      <p:sp>
        <p:nvSpPr>
          <p:cNvPr id="6" name="テキスト ボックス 5"/>
          <p:cNvSpPr txBox="1"/>
          <p:nvPr/>
        </p:nvSpPr>
        <p:spPr>
          <a:xfrm>
            <a:off x="-9525" y="42738973"/>
            <a:ext cx="76390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>
                <a:latin typeface="Arial"/>
                <a:ea typeface="Arial Unicode MS" panose="020B0604020202020204" pitchFamily="50" charset="-128"/>
                <a:cs typeface="Arial"/>
              </a:rPr>
              <a:t>Figure S3. </a:t>
            </a:r>
            <a:r>
              <a:rPr lang="en-US" altLang="ja-JP" sz="1200" dirty="0">
                <a:latin typeface="Arial"/>
                <a:ea typeface="Arial Unicode MS" panose="020B0604020202020204" pitchFamily="50" charset="-128"/>
                <a:cs typeface="Arial"/>
              </a:rPr>
              <a:t>A phylogenetic tree created based on the genome DNA sequences of DNA gyrase subunit B</a:t>
            </a:r>
            <a:r>
              <a:rPr lang="ja-JP" altLang="en-US" sz="1200" dirty="0">
                <a:latin typeface="Arial"/>
                <a:ea typeface="Arial Unicode MS" panose="020B0604020202020204" pitchFamily="50" charset="-128"/>
                <a:cs typeface="Arial"/>
              </a:rPr>
              <a:t> </a:t>
            </a:r>
            <a:r>
              <a:rPr lang="en-US" altLang="ja-JP" sz="1200" dirty="0">
                <a:latin typeface="Arial"/>
                <a:ea typeface="Arial Unicode MS" panose="020B0604020202020204" pitchFamily="50" charset="-128"/>
                <a:cs typeface="Arial"/>
              </a:rPr>
              <a:t>for 296 species. </a:t>
            </a:r>
            <a:endParaRPr lang="ja-JP" altLang="en-US" sz="1200" dirty="0">
              <a:latin typeface="Arial"/>
              <a:ea typeface="Arial Unicode MS" panose="020B0604020202020204" pitchFamily="50" charset="-128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6939684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22</Words>
  <Application>Microsoft Macintosh PowerPoint</Application>
  <PresentationFormat>ユーザー設定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 Unicode MS</vt:lpstr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tuyama</dc:creator>
  <cp:lastModifiedBy>五十嵐洋治</cp:lastModifiedBy>
  <cp:revision>14</cp:revision>
  <dcterms:created xsi:type="dcterms:W3CDTF">2018-08-17T07:55:13Z</dcterms:created>
  <dcterms:modified xsi:type="dcterms:W3CDTF">2019-02-20T05:19:49Z</dcterms:modified>
</cp:coreProperties>
</file>